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59" autoAdjust="0"/>
    <p:restoredTop sz="94660"/>
  </p:normalViewPr>
  <p:slideViewPr>
    <p:cSldViewPr snapToGrid="0" showGuides="1">
      <p:cViewPr varScale="1">
        <p:scale>
          <a:sx n="117" d="100"/>
          <a:sy n="117" d="100"/>
        </p:scale>
        <p:origin x="-156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47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6522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062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1097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1516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320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9433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422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7201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8592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38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942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33120" y="853085"/>
            <a:ext cx="8712968" cy="49003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200" dirty="0">
                <a:effectLst/>
                <a:ea typeface="Times New Roman"/>
                <a:cs typeface="Courier New" panose="02070309020205020404" pitchFamily="49" charset="0"/>
              </a:rPr>
              <a:t>A. Peptide epitopes compiled into </a:t>
            </a:r>
            <a:r>
              <a:rPr lang="en-GB" sz="1200" dirty="0">
                <a:ea typeface="Times New Roman"/>
                <a:cs typeface="Courier New" panose="02070309020205020404" pitchFamily="49" charset="0"/>
              </a:rPr>
              <a:t>the</a:t>
            </a:r>
            <a:r>
              <a:rPr lang="en-GB" sz="1200" dirty="0">
                <a:effectLst/>
                <a:ea typeface="Times New Roman"/>
                <a:cs typeface="Courier New" panose="02070309020205020404" pitchFamily="49" charset="0"/>
              </a:rPr>
              <a:t> the vaccine construct</a:t>
            </a:r>
            <a:endParaRPr lang="en-GB" sz="1200" dirty="0">
              <a:effectLst/>
              <a:ea typeface="Calibri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KLIQFFAYLVEEGDFYELEPPVHYYDYSV</a:t>
            </a:r>
            <a:r>
              <a:rPr lang="en-GB" sz="12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HSMPKYEVLWTEELRPDIDKFHYDDTFRDFPRQKLREEENP</a:t>
            </a: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RKPKDVQQLGEKKTIMQKINDGFFYLFSEQEFHPLHDKSYLFNIWYL</a:t>
            </a:r>
            <a:r>
              <a:rPr lang="en-GB" sz="12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EKIVNGFNSIFGVEEFNPPKDSYFVDRLW</a:t>
            </a: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KDEAKPEESQFFAIPFMMTIGSHLW</a:t>
            </a:r>
            <a:r>
              <a:rPr lang="en-GB" sz="12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GEEQNPEPPRPRRKHPVLREVFL</a:t>
            </a: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NSSKWTYVGQNVAVVS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G-4.1C; 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G-4.2;  </a:t>
            </a:r>
            <a:r>
              <a:rPr lang="en-GB" sz="12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G-8.1C; 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G-8.2C;  </a:t>
            </a:r>
            <a:r>
              <a:rPr lang="en-GB" sz="12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G-9; 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G-11;  </a:t>
            </a:r>
            <a:r>
              <a:rPr lang="en-GB" sz="12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AL-7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sz="1200" dirty="0">
              <a:cs typeface="Courier New" panose="02070309020205020404" pitchFamily="49" charset="0"/>
            </a:endParaRPr>
          </a:p>
          <a:p>
            <a:r>
              <a:rPr lang="en-GB" sz="1200" dirty="0">
                <a:cs typeface="Courier New" panose="02070309020205020404" pitchFamily="49" charset="0"/>
              </a:rPr>
              <a:t>B. Synthetic gene sequence</a:t>
            </a:r>
          </a:p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GAGAAGCTAATTCAATTTTTCGCATACTTGGTAGAAGAAGGTGACTTTTATGAACTCGAGCCTCCAGTACACTATTACGACTATTCAGTACATTCGATGCCTAAATATGAAGTTCTGTGGACAGAAGAGTTACGTCCTGACATCGACAAGTTTCATTACGATGACACATTTAGAGATTTTCCACGTCAAAAATTAAGGGAAGAAGAAAATCCAAGAAAACCAAAAGATGTTCAACAACTTGGAGAAAAAAAAACAATTATGCAAAAAATCAACGATGGATTTTTCTACCTATTCAGTGAACAAGAATTTCACCCACTACATGATAAAAGTTATTTATTCAATATCTGGTACCTTGAAAAAATCGTCAATGGATTCAACAGCATTTTTGGAGTAGAAGAATTTAATCCACCGAAAGACAGTTATTTCGTTGATAGATTATGGAAGGATGAAGCTAAACCTGAAGAGTCACAGTTTTTCGCAATTCCTTTCATGATGACTATTGGATCTCATTTGTGGGATGGTGAAGAACAAAATCCAGAGCCACCGCGCCCACGAAGGAAGCATCCAGTTTTAAGAGAAGTATTTCTAAATAGTTCAAAATGGACTTATGTCGGTCAGAATGTTGCTGTTGTTTCA</a:t>
            </a:r>
          </a:p>
          <a:p>
            <a:endParaRPr lang="en-GB" sz="1200" dirty="0">
              <a:cs typeface="Courier New" panose="02070309020205020404" pitchFamily="49" charset="0"/>
            </a:endParaRPr>
          </a:p>
          <a:p>
            <a:endParaRPr lang="en-GB" sz="1200" dirty="0">
              <a:cs typeface="Courier New" panose="02070309020205020404" pitchFamily="49" charset="0"/>
            </a:endParaRPr>
          </a:p>
          <a:p>
            <a:r>
              <a:rPr lang="en-GB" sz="1200" dirty="0">
                <a:cs typeface="Courier New" panose="02070309020205020404" pitchFamily="49" charset="0"/>
              </a:rPr>
              <a:t>Codon optimised for </a:t>
            </a:r>
            <a:r>
              <a:rPr lang="en-GB" sz="1200" i="1" dirty="0">
                <a:cs typeface="Courier New" panose="02070309020205020404" pitchFamily="49" charset="0"/>
              </a:rPr>
              <a:t>E. coli </a:t>
            </a:r>
            <a:r>
              <a:rPr lang="en-GB" sz="1200" dirty="0">
                <a:cs typeface="Courier New" panose="02070309020205020404" pitchFamily="49" charset="0"/>
              </a:rPr>
              <a:t>expression</a:t>
            </a:r>
          </a:p>
          <a:p>
            <a:pPr>
              <a:lnSpc>
                <a:spcPct val="115000"/>
              </a:lnSpc>
            </a:pPr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GAAAAGCTGATTCAATTCTTCGCATACCTGGTTGAAGAGGGCGACTTCTACGAACTGGAACCGCCGGTTCATTATTACGATTATAGCGTGCACTCCATGCCGAAATACGAAGTTCTGTGGACCGAAGAGCTGCGTCCGGACATTGACAAATTCCACTATGACGATACTTTCCGTGATTTTCCGCGCCAGAAACTGCGTGAAGAAGAAAACCCACGTAAACCAAAGGATGTGCAGCAGCTGGGCGAAAAGAAGACAATCATGCAGAAAATTAACGATGGGTTCTTCTACCTGTTCTCTGAACAGGAATTTCACCCGTTACACGATAAATCTTATCTGTTTAATATTTGGTACTTAGAAAAAATTGTAAACGGTTTCAACAGCATCTTCGGTGTTGAAGAATTCAACCCGCCGAAAGACAGCTATTTTGTTGATCGTCTGTGGAAAGATGAAGCTAAACCAGAAGAGTCGCAGTTCTTCGCAATCCCGTTTATGATGACCATCGGCTCCCACCTGTGGGACGGCGAGGAGCAGAACCCGGAACCTCCACGCCCACGTCGCAAGCACCCGGTTCTGCGTGAGGTATTCCTGAATTCTTCCAAATGGACATATGTCGGCCAAAACGTCGCAGTTGTGTCC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30924" y="6127531"/>
            <a:ext cx="83031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Note information on how the epitopes were chosen is in file 160301 Selection of peptides…</a:t>
            </a:r>
          </a:p>
          <a:p>
            <a:r>
              <a:rPr lang="en-GB" sz="1200" dirty="0"/>
              <a:t>Note also that as of 10/04/19, the epitopes detected by array 2b have not </a:t>
            </a:r>
            <a:r>
              <a:rPr lang="en-GB" sz="1200"/>
              <a:t>been extracted.</a:t>
            </a:r>
            <a:endParaRPr lang="en-GB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430924" y="203409"/>
            <a:ext cx="2869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3 Fig.</a:t>
            </a:r>
          </a:p>
        </p:txBody>
      </p:sp>
    </p:spTree>
    <p:extLst>
      <p:ext uri="{BB962C8B-B14F-4D97-AF65-F5344CB8AC3E}">
        <p14:creationId xmlns:p14="http://schemas.microsoft.com/office/powerpoint/2010/main" val="1117923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7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Y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Wilson</dc:creator>
  <cp:lastModifiedBy>Roopavathy</cp:lastModifiedBy>
  <cp:revision>4</cp:revision>
  <dcterms:created xsi:type="dcterms:W3CDTF">2019-08-28T10:03:25Z</dcterms:created>
  <dcterms:modified xsi:type="dcterms:W3CDTF">2020-02-17T06:20:04Z</dcterms:modified>
</cp:coreProperties>
</file>